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56" r:id="rId2"/>
  </p:sldIdLst>
  <p:sldSz cx="21674138" cy="2889885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103" userDrawn="1">
          <p15:clr>
            <a:srgbClr val="A4A3A4"/>
          </p15:clr>
        </p15:guide>
        <p15:guide id="2" pos="68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3" d="100"/>
          <a:sy n="33" d="100"/>
        </p:scale>
        <p:origin x="888" y="24"/>
      </p:cViewPr>
      <p:guideLst>
        <p:guide orient="horz" pos="9103"/>
        <p:guide pos="68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B42AEA-8964-4CEB-AFE6-EA11A1AB39C5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F5128-DB79-4CCB-89CD-B99B04EBE9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67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FF5128-DB79-4CCB-89CD-B99B04EBE95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34826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625562" y="8977387"/>
            <a:ext cx="18423018" cy="6194521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3251122" y="16376017"/>
            <a:ext cx="15171897" cy="738526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7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4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08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3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3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0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1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6663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7424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15713750" y="1157306"/>
            <a:ext cx="4876681" cy="2465767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1083708" y="1157306"/>
            <a:ext cx="14268808" cy="2465767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751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2612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12110" y="18570189"/>
            <a:ext cx="18423018" cy="5739632"/>
          </a:xfrm>
        </p:spPr>
        <p:txBody>
          <a:bodyPr anchor="t"/>
          <a:lstStyle>
            <a:lvl1pPr algn="l">
              <a:defRPr sz="7113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1712110" y="12248574"/>
            <a:ext cx="18423018" cy="6321620"/>
          </a:xfrm>
        </p:spPr>
        <p:txBody>
          <a:bodyPr anchor="b"/>
          <a:lstStyle>
            <a:lvl1pPr marL="0" indent="0">
              <a:buNone/>
              <a:defRPr sz="3557">
                <a:solidFill>
                  <a:schemeClr val="tx1">
                    <a:tint val="75000"/>
                  </a:schemeClr>
                </a:solidFill>
              </a:defRPr>
            </a:lvl1pPr>
            <a:lvl2pPr marL="812719" indent="0">
              <a:buNone/>
              <a:defRPr sz="3199">
                <a:solidFill>
                  <a:schemeClr val="tx1">
                    <a:tint val="75000"/>
                  </a:schemeClr>
                </a:solidFill>
              </a:defRPr>
            </a:lvl2pPr>
            <a:lvl3pPr marL="1625442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162" indent="0">
              <a:buNone/>
              <a:defRPr sz="2491">
                <a:solidFill>
                  <a:schemeClr val="tx1">
                    <a:tint val="75000"/>
                  </a:schemeClr>
                </a:solidFill>
              </a:defRPr>
            </a:lvl4pPr>
            <a:lvl5pPr marL="3250880" indent="0">
              <a:buNone/>
              <a:defRPr sz="2491">
                <a:solidFill>
                  <a:schemeClr val="tx1">
                    <a:tint val="75000"/>
                  </a:schemeClr>
                </a:solidFill>
              </a:defRPr>
            </a:lvl5pPr>
            <a:lvl6pPr marL="4063600" indent="0">
              <a:buNone/>
              <a:defRPr sz="2491">
                <a:solidFill>
                  <a:schemeClr val="tx1">
                    <a:tint val="75000"/>
                  </a:schemeClr>
                </a:solidFill>
              </a:defRPr>
            </a:lvl6pPr>
            <a:lvl7pPr marL="4876323" indent="0">
              <a:buNone/>
              <a:defRPr sz="2491">
                <a:solidFill>
                  <a:schemeClr val="tx1">
                    <a:tint val="75000"/>
                  </a:schemeClr>
                </a:solidFill>
              </a:defRPr>
            </a:lvl7pPr>
            <a:lvl8pPr marL="5689042" indent="0">
              <a:buNone/>
              <a:defRPr sz="2491">
                <a:solidFill>
                  <a:schemeClr val="tx1">
                    <a:tint val="75000"/>
                  </a:schemeClr>
                </a:solidFill>
              </a:defRPr>
            </a:lvl8pPr>
            <a:lvl9pPr marL="6501760" indent="0">
              <a:buNone/>
              <a:defRPr sz="24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8935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1083707" y="6743073"/>
            <a:ext cx="9572744" cy="19071904"/>
          </a:xfrm>
        </p:spPr>
        <p:txBody>
          <a:bodyPr/>
          <a:lstStyle>
            <a:lvl1pPr>
              <a:defRPr sz="4976"/>
            </a:lvl1pPr>
            <a:lvl2pPr>
              <a:defRPr sz="4268"/>
            </a:lvl2pPr>
            <a:lvl3pPr>
              <a:defRPr sz="3557"/>
            </a:lvl3pPr>
            <a:lvl4pPr>
              <a:defRPr sz="3199"/>
            </a:lvl4pPr>
            <a:lvl5pPr>
              <a:defRPr sz="3199"/>
            </a:lvl5pPr>
            <a:lvl6pPr>
              <a:defRPr sz="3199"/>
            </a:lvl6pPr>
            <a:lvl7pPr>
              <a:defRPr sz="3199"/>
            </a:lvl7pPr>
            <a:lvl8pPr>
              <a:defRPr sz="3199"/>
            </a:lvl8pPr>
            <a:lvl9pPr>
              <a:defRPr sz="319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11017688" y="6743073"/>
            <a:ext cx="9572744" cy="19071904"/>
          </a:xfrm>
        </p:spPr>
        <p:txBody>
          <a:bodyPr/>
          <a:lstStyle>
            <a:lvl1pPr>
              <a:defRPr sz="4976"/>
            </a:lvl1pPr>
            <a:lvl2pPr>
              <a:defRPr sz="4268"/>
            </a:lvl2pPr>
            <a:lvl3pPr>
              <a:defRPr sz="3557"/>
            </a:lvl3pPr>
            <a:lvl4pPr>
              <a:defRPr sz="3199"/>
            </a:lvl4pPr>
            <a:lvl5pPr>
              <a:defRPr sz="3199"/>
            </a:lvl5pPr>
            <a:lvl6pPr>
              <a:defRPr sz="3199"/>
            </a:lvl6pPr>
            <a:lvl7pPr>
              <a:defRPr sz="3199"/>
            </a:lvl7pPr>
            <a:lvl8pPr>
              <a:defRPr sz="3199"/>
            </a:lvl8pPr>
            <a:lvl9pPr>
              <a:defRPr sz="319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1640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1083707" y="6468799"/>
            <a:ext cx="9576508" cy="2695887"/>
          </a:xfrm>
        </p:spPr>
        <p:txBody>
          <a:bodyPr anchor="b"/>
          <a:lstStyle>
            <a:lvl1pPr marL="0" indent="0">
              <a:buNone/>
              <a:defRPr sz="4268" b="1"/>
            </a:lvl1pPr>
            <a:lvl2pPr marL="812719" indent="0">
              <a:buNone/>
              <a:defRPr sz="3557" b="1"/>
            </a:lvl2pPr>
            <a:lvl3pPr marL="1625442" indent="0">
              <a:buNone/>
              <a:defRPr sz="3199" b="1"/>
            </a:lvl3pPr>
            <a:lvl4pPr marL="2438162" indent="0">
              <a:buNone/>
              <a:defRPr sz="2844" b="1"/>
            </a:lvl4pPr>
            <a:lvl5pPr marL="3250880" indent="0">
              <a:buNone/>
              <a:defRPr sz="2844" b="1"/>
            </a:lvl5pPr>
            <a:lvl6pPr marL="4063600" indent="0">
              <a:buNone/>
              <a:defRPr sz="2844" b="1"/>
            </a:lvl6pPr>
            <a:lvl7pPr marL="4876323" indent="0">
              <a:buNone/>
              <a:defRPr sz="2844" b="1"/>
            </a:lvl7pPr>
            <a:lvl8pPr marL="5689042" indent="0">
              <a:buNone/>
              <a:defRPr sz="2844" b="1"/>
            </a:lvl8pPr>
            <a:lvl9pPr marL="6501760" indent="0">
              <a:buNone/>
              <a:defRPr sz="2844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1083707" y="9164682"/>
            <a:ext cx="9576508" cy="16650289"/>
          </a:xfrm>
        </p:spPr>
        <p:txBody>
          <a:bodyPr/>
          <a:lstStyle>
            <a:lvl1pPr>
              <a:defRPr sz="4268"/>
            </a:lvl1pPr>
            <a:lvl2pPr>
              <a:defRPr sz="3557"/>
            </a:lvl2pPr>
            <a:lvl3pPr>
              <a:defRPr sz="3199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11010166" y="6468799"/>
            <a:ext cx="9580270" cy="2695887"/>
          </a:xfrm>
        </p:spPr>
        <p:txBody>
          <a:bodyPr anchor="b"/>
          <a:lstStyle>
            <a:lvl1pPr marL="0" indent="0">
              <a:buNone/>
              <a:defRPr sz="4268" b="1"/>
            </a:lvl1pPr>
            <a:lvl2pPr marL="812719" indent="0">
              <a:buNone/>
              <a:defRPr sz="3557" b="1"/>
            </a:lvl2pPr>
            <a:lvl3pPr marL="1625442" indent="0">
              <a:buNone/>
              <a:defRPr sz="3199" b="1"/>
            </a:lvl3pPr>
            <a:lvl4pPr marL="2438162" indent="0">
              <a:buNone/>
              <a:defRPr sz="2844" b="1"/>
            </a:lvl4pPr>
            <a:lvl5pPr marL="3250880" indent="0">
              <a:buNone/>
              <a:defRPr sz="2844" b="1"/>
            </a:lvl5pPr>
            <a:lvl6pPr marL="4063600" indent="0">
              <a:buNone/>
              <a:defRPr sz="2844" b="1"/>
            </a:lvl6pPr>
            <a:lvl7pPr marL="4876323" indent="0">
              <a:buNone/>
              <a:defRPr sz="2844" b="1"/>
            </a:lvl7pPr>
            <a:lvl8pPr marL="5689042" indent="0">
              <a:buNone/>
              <a:defRPr sz="2844" b="1"/>
            </a:lvl8pPr>
            <a:lvl9pPr marL="6501760" indent="0">
              <a:buNone/>
              <a:defRPr sz="2844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11010166" y="9164682"/>
            <a:ext cx="9580270" cy="16650289"/>
          </a:xfrm>
        </p:spPr>
        <p:txBody>
          <a:bodyPr/>
          <a:lstStyle>
            <a:lvl1pPr>
              <a:defRPr sz="4268"/>
            </a:lvl1pPr>
            <a:lvl2pPr>
              <a:defRPr sz="3557"/>
            </a:lvl2pPr>
            <a:lvl3pPr>
              <a:defRPr sz="3199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436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032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752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83710" y="1150605"/>
            <a:ext cx="7130643" cy="4896749"/>
          </a:xfrm>
        </p:spPr>
        <p:txBody>
          <a:bodyPr anchor="b"/>
          <a:lstStyle>
            <a:lvl1pPr algn="l">
              <a:defRPr sz="3557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8473987" y="1150610"/>
            <a:ext cx="12116448" cy="24664369"/>
          </a:xfrm>
        </p:spPr>
        <p:txBody>
          <a:bodyPr/>
          <a:lstStyle>
            <a:lvl1pPr>
              <a:defRPr sz="5689"/>
            </a:lvl1pPr>
            <a:lvl2pPr>
              <a:defRPr sz="4976"/>
            </a:lvl2pPr>
            <a:lvl3pPr>
              <a:defRPr sz="4268"/>
            </a:lvl3pPr>
            <a:lvl4pPr>
              <a:defRPr sz="3557"/>
            </a:lvl4pPr>
            <a:lvl5pPr>
              <a:defRPr sz="3557"/>
            </a:lvl5pPr>
            <a:lvl6pPr>
              <a:defRPr sz="3557"/>
            </a:lvl6pPr>
            <a:lvl7pPr>
              <a:defRPr sz="3557"/>
            </a:lvl7pPr>
            <a:lvl8pPr>
              <a:defRPr sz="3557"/>
            </a:lvl8pPr>
            <a:lvl9pPr>
              <a:defRPr sz="3557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083710" y="6047361"/>
            <a:ext cx="7130643" cy="19767618"/>
          </a:xfrm>
        </p:spPr>
        <p:txBody>
          <a:bodyPr/>
          <a:lstStyle>
            <a:lvl1pPr marL="0" indent="0">
              <a:buNone/>
              <a:defRPr sz="2491"/>
            </a:lvl1pPr>
            <a:lvl2pPr marL="812719" indent="0">
              <a:buNone/>
              <a:defRPr sz="2132"/>
            </a:lvl2pPr>
            <a:lvl3pPr marL="1625442" indent="0">
              <a:buNone/>
              <a:defRPr sz="1777"/>
            </a:lvl3pPr>
            <a:lvl4pPr marL="2438162" indent="0">
              <a:buNone/>
              <a:defRPr sz="1601"/>
            </a:lvl4pPr>
            <a:lvl5pPr marL="3250880" indent="0">
              <a:buNone/>
              <a:defRPr sz="1601"/>
            </a:lvl5pPr>
            <a:lvl6pPr marL="4063600" indent="0">
              <a:buNone/>
              <a:defRPr sz="1601"/>
            </a:lvl6pPr>
            <a:lvl7pPr marL="4876323" indent="0">
              <a:buNone/>
              <a:defRPr sz="1601"/>
            </a:lvl7pPr>
            <a:lvl8pPr marL="5689042" indent="0">
              <a:buNone/>
              <a:defRPr sz="1601"/>
            </a:lvl8pPr>
            <a:lvl9pPr marL="6501760" indent="0">
              <a:buNone/>
              <a:defRPr sz="160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650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248283" y="20229198"/>
            <a:ext cx="13004483" cy="2388173"/>
          </a:xfrm>
        </p:spPr>
        <p:txBody>
          <a:bodyPr anchor="b"/>
          <a:lstStyle>
            <a:lvl1pPr algn="l">
              <a:defRPr sz="3557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4248283" y="2582166"/>
            <a:ext cx="13004483" cy="17339310"/>
          </a:xfrm>
        </p:spPr>
        <p:txBody>
          <a:bodyPr/>
          <a:lstStyle>
            <a:lvl1pPr marL="0" indent="0">
              <a:buNone/>
              <a:defRPr sz="5689"/>
            </a:lvl1pPr>
            <a:lvl2pPr marL="812719" indent="0">
              <a:buNone/>
              <a:defRPr sz="4976"/>
            </a:lvl2pPr>
            <a:lvl3pPr marL="1625442" indent="0">
              <a:buNone/>
              <a:defRPr sz="4268"/>
            </a:lvl3pPr>
            <a:lvl4pPr marL="2438162" indent="0">
              <a:buNone/>
              <a:defRPr sz="3557"/>
            </a:lvl4pPr>
            <a:lvl5pPr marL="3250880" indent="0">
              <a:buNone/>
              <a:defRPr sz="3557"/>
            </a:lvl5pPr>
            <a:lvl6pPr marL="4063600" indent="0">
              <a:buNone/>
              <a:defRPr sz="3557"/>
            </a:lvl6pPr>
            <a:lvl7pPr marL="4876323" indent="0">
              <a:buNone/>
              <a:defRPr sz="3557"/>
            </a:lvl7pPr>
            <a:lvl8pPr marL="5689042" indent="0">
              <a:buNone/>
              <a:defRPr sz="3557"/>
            </a:lvl8pPr>
            <a:lvl9pPr marL="6501760" indent="0">
              <a:buNone/>
              <a:defRPr sz="3557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248283" y="22617372"/>
            <a:ext cx="13004483" cy="3391597"/>
          </a:xfrm>
        </p:spPr>
        <p:txBody>
          <a:bodyPr/>
          <a:lstStyle>
            <a:lvl1pPr marL="0" indent="0">
              <a:buNone/>
              <a:defRPr sz="2491"/>
            </a:lvl1pPr>
            <a:lvl2pPr marL="812719" indent="0">
              <a:buNone/>
              <a:defRPr sz="2132"/>
            </a:lvl2pPr>
            <a:lvl3pPr marL="1625442" indent="0">
              <a:buNone/>
              <a:defRPr sz="1777"/>
            </a:lvl3pPr>
            <a:lvl4pPr marL="2438162" indent="0">
              <a:buNone/>
              <a:defRPr sz="1601"/>
            </a:lvl4pPr>
            <a:lvl5pPr marL="3250880" indent="0">
              <a:buNone/>
              <a:defRPr sz="1601"/>
            </a:lvl5pPr>
            <a:lvl6pPr marL="4063600" indent="0">
              <a:buNone/>
              <a:defRPr sz="1601"/>
            </a:lvl6pPr>
            <a:lvl7pPr marL="4876323" indent="0">
              <a:buNone/>
              <a:defRPr sz="1601"/>
            </a:lvl7pPr>
            <a:lvl8pPr marL="5689042" indent="0">
              <a:buNone/>
              <a:defRPr sz="1601"/>
            </a:lvl8pPr>
            <a:lvl9pPr marL="6501760" indent="0">
              <a:buNone/>
              <a:defRPr sz="160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0529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1083708" y="1157297"/>
            <a:ext cx="19506724" cy="48164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1083708" y="6743073"/>
            <a:ext cx="19506724" cy="190719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1083707" y="26784964"/>
            <a:ext cx="5057300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0C499-AE5A-486E-A1EA-781931F6BB09}" type="datetimeFigureOut">
              <a:rPr kumimoji="1" lang="ja-JP" altLang="en-US" smtClean="0"/>
              <a:t>2019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7405334" y="26784964"/>
            <a:ext cx="6863477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15533132" y="26784964"/>
            <a:ext cx="5057300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6D9CB1-01DC-4F76-B998-DE14B517C9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380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442" rtl="0" eaLnBrk="1" latinLnBrk="0" hangingPunct="1">
        <a:spcBef>
          <a:spcPct val="0"/>
        </a:spcBef>
        <a:buNone/>
        <a:defRPr kumimoji="1" sz="78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540" indent="-609540" algn="l" defTabSz="162544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671" indent="-507951" algn="l" defTabSz="1625442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4976" kern="1200">
          <a:solidFill>
            <a:schemeClr val="tx1"/>
          </a:solidFill>
          <a:latin typeface="+mn-lt"/>
          <a:ea typeface="+mn-ea"/>
          <a:cs typeface="+mn-cs"/>
        </a:defRPr>
      </a:lvl2pPr>
      <a:lvl3pPr marL="2031800" indent="-406361" algn="l" defTabSz="162544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268" kern="1200">
          <a:solidFill>
            <a:schemeClr val="tx1"/>
          </a:solidFill>
          <a:latin typeface="+mn-lt"/>
          <a:ea typeface="+mn-ea"/>
          <a:cs typeface="+mn-cs"/>
        </a:defRPr>
      </a:lvl3pPr>
      <a:lvl4pPr marL="2844520" indent="-406361" algn="l" defTabSz="1625442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557" kern="1200">
          <a:solidFill>
            <a:schemeClr val="tx1"/>
          </a:solidFill>
          <a:latin typeface="+mn-lt"/>
          <a:ea typeface="+mn-ea"/>
          <a:cs typeface="+mn-cs"/>
        </a:defRPr>
      </a:lvl4pPr>
      <a:lvl5pPr marL="3657242" indent="-406361" algn="l" defTabSz="1625442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3557" kern="1200">
          <a:solidFill>
            <a:schemeClr val="tx1"/>
          </a:solidFill>
          <a:latin typeface="+mn-lt"/>
          <a:ea typeface="+mn-ea"/>
          <a:cs typeface="+mn-cs"/>
        </a:defRPr>
      </a:lvl5pPr>
      <a:lvl6pPr marL="4469962" indent="-406361" algn="l" defTabSz="162544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557" kern="1200">
          <a:solidFill>
            <a:schemeClr val="tx1"/>
          </a:solidFill>
          <a:latin typeface="+mn-lt"/>
          <a:ea typeface="+mn-ea"/>
          <a:cs typeface="+mn-cs"/>
        </a:defRPr>
      </a:lvl6pPr>
      <a:lvl7pPr marL="5282678" indent="-406361" algn="l" defTabSz="162544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557" kern="1200">
          <a:solidFill>
            <a:schemeClr val="tx1"/>
          </a:solidFill>
          <a:latin typeface="+mn-lt"/>
          <a:ea typeface="+mn-ea"/>
          <a:cs typeface="+mn-cs"/>
        </a:defRPr>
      </a:lvl7pPr>
      <a:lvl8pPr marL="6095397" indent="-406361" algn="l" defTabSz="162544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557" kern="1200">
          <a:solidFill>
            <a:schemeClr val="tx1"/>
          </a:solidFill>
          <a:latin typeface="+mn-lt"/>
          <a:ea typeface="+mn-ea"/>
          <a:cs typeface="+mn-cs"/>
        </a:defRPr>
      </a:lvl8pPr>
      <a:lvl9pPr marL="6908122" indent="-406361" algn="l" defTabSz="162544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55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625442" rtl="0" eaLnBrk="1" latinLnBrk="0" hangingPunct="1">
        <a:defRPr kumimoji="1" sz="3199" kern="1200">
          <a:solidFill>
            <a:schemeClr val="tx1"/>
          </a:solidFill>
          <a:latin typeface="+mn-lt"/>
          <a:ea typeface="+mn-ea"/>
          <a:cs typeface="+mn-cs"/>
        </a:defRPr>
      </a:lvl1pPr>
      <a:lvl2pPr marL="812719" algn="l" defTabSz="1625442" rtl="0" eaLnBrk="1" latinLnBrk="0" hangingPunct="1">
        <a:defRPr kumimoji="1" sz="3199" kern="1200">
          <a:solidFill>
            <a:schemeClr val="tx1"/>
          </a:solidFill>
          <a:latin typeface="+mn-lt"/>
          <a:ea typeface="+mn-ea"/>
          <a:cs typeface="+mn-cs"/>
        </a:defRPr>
      </a:lvl2pPr>
      <a:lvl3pPr marL="1625442" algn="l" defTabSz="1625442" rtl="0" eaLnBrk="1" latinLnBrk="0" hangingPunct="1">
        <a:defRPr kumimoji="1" sz="3199" kern="1200">
          <a:solidFill>
            <a:schemeClr val="tx1"/>
          </a:solidFill>
          <a:latin typeface="+mn-lt"/>
          <a:ea typeface="+mn-ea"/>
          <a:cs typeface="+mn-cs"/>
        </a:defRPr>
      </a:lvl3pPr>
      <a:lvl4pPr marL="2438162" algn="l" defTabSz="1625442" rtl="0" eaLnBrk="1" latinLnBrk="0" hangingPunct="1">
        <a:defRPr kumimoji="1" sz="3199" kern="1200">
          <a:solidFill>
            <a:schemeClr val="tx1"/>
          </a:solidFill>
          <a:latin typeface="+mn-lt"/>
          <a:ea typeface="+mn-ea"/>
          <a:cs typeface="+mn-cs"/>
        </a:defRPr>
      </a:lvl4pPr>
      <a:lvl5pPr marL="3250880" algn="l" defTabSz="1625442" rtl="0" eaLnBrk="1" latinLnBrk="0" hangingPunct="1">
        <a:defRPr kumimoji="1" sz="3199" kern="1200">
          <a:solidFill>
            <a:schemeClr val="tx1"/>
          </a:solidFill>
          <a:latin typeface="+mn-lt"/>
          <a:ea typeface="+mn-ea"/>
          <a:cs typeface="+mn-cs"/>
        </a:defRPr>
      </a:lvl5pPr>
      <a:lvl6pPr marL="4063600" algn="l" defTabSz="1625442" rtl="0" eaLnBrk="1" latinLnBrk="0" hangingPunct="1">
        <a:defRPr kumimoji="1" sz="3199" kern="1200">
          <a:solidFill>
            <a:schemeClr val="tx1"/>
          </a:solidFill>
          <a:latin typeface="+mn-lt"/>
          <a:ea typeface="+mn-ea"/>
          <a:cs typeface="+mn-cs"/>
        </a:defRPr>
      </a:lvl6pPr>
      <a:lvl7pPr marL="4876323" algn="l" defTabSz="1625442" rtl="0" eaLnBrk="1" latinLnBrk="0" hangingPunct="1">
        <a:defRPr kumimoji="1" sz="3199" kern="1200">
          <a:solidFill>
            <a:schemeClr val="tx1"/>
          </a:solidFill>
          <a:latin typeface="+mn-lt"/>
          <a:ea typeface="+mn-ea"/>
          <a:cs typeface="+mn-cs"/>
        </a:defRPr>
      </a:lvl7pPr>
      <a:lvl8pPr marL="5689042" algn="l" defTabSz="1625442" rtl="0" eaLnBrk="1" latinLnBrk="0" hangingPunct="1">
        <a:defRPr kumimoji="1" sz="3199" kern="1200">
          <a:solidFill>
            <a:schemeClr val="tx1"/>
          </a:solidFill>
          <a:latin typeface="+mn-lt"/>
          <a:ea typeface="+mn-ea"/>
          <a:cs typeface="+mn-cs"/>
        </a:defRPr>
      </a:lvl8pPr>
      <a:lvl9pPr marL="6501760" algn="l" defTabSz="1625442" rtl="0" eaLnBrk="1" latinLnBrk="0" hangingPunct="1">
        <a:defRPr kumimoji="1" sz="319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66" t="16242" r="14360" b="11407"/>
          <a:stretch/>
        </p:blipFill>
        <p:spPr bwMode="auto">
          <a:xfrm>
            <a:off x="827957" y="12686185"/>
            <a:ext cx="4700561" cy="4798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66" t="15420" r="14360" b="12229"/>
          <a:stretch/>
        </p:blipFill>
        <p:spPr bwMode="auto">
          <a:xfrm>
            <a:off x="827957" y="2718955"/>
            <a:ext cx="4700561" cy="4798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66" t="15797" r="14360" b="11853"/>
          <a:stretch/>
        </p:blipFill>
        <p:spPr bwMode="auto">
          <a:xfrm>
            <a:off x="827957" y="7696556"/>
            <a:ext cx="4700561" cy="4798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66" t="16046" r="14259" b="11603"/>
          <a:stretch/>
        </p:blipFill>
        <p:spPr bwMode="auto">
          <a:xfrm>
            <a:off x="5985085" y="2718955"/>
            <a:ext cx="4707276" cy="47984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89" t="16419" r="15736" b="11231"/>
          <a:stretch/>
        </p:blipFill>
        <p:spPr bwMode="auto">
          <a:xfrm>
            <a:off x="5985085" y="7696556"/>
            <a:ext cx="4707276" cy="47984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86" t="17718" r="14140" b="9932"/>
          <a:stretch/>
        </p:blipFill>
        <p:spPr bwMode="auto">
          <a:xfrm>
            <a:off x="5988441" y="12686185"/>
            <a:ext cx="4700564" cy="4798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9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86" t="21879" r="14140" b="5771"/>
          <a:stretch/>
        </p:blipFill>
        <p:spPr bwMode="auto">
          <a:xfrm>
            <a:off x="5988441" y="17747468"/>
            <a:ext cx="4700564" cy="4798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10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61" t="17718" r="13664" b="9932"/>
          <a:stretch/>
        </p:blipFill>
        <p:spPr bwMode="auto">
          <a:xfrm>
            <a:off x="5978452" y="22750420"/>
            <a:ext cx="4700564" cy="4798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3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90" t="16241" r="15837" b="11409"/>
          <a:stretch/>
        </p:blipFill>
        <p:spPr bwMode="auto">
          <a:xfrm>
            <a:off x="11073134" y="2718955"/>
            <a:ext cx="4700561" cy="4798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4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10" t="16242" r="16515" b="12188"/>
          <a:stretch/>
        </p:blipFill>
        <p:spPr bwMode="auto">
          <a:xfrm>
            <a:off x="11073134" y="7722429"/>
            <a:ext cx="4700560" cy="4746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5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83" t="18576" r="16042" b="8983"/>
          <a:stretch/>
        </p:blipFill>
        <p:spPr bwMode="auto">
          <a:xfrm>
            <a:off x="11073134" y="12683199"/>
            <a:ext cx="4700560" cy="48044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6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92" t="22149" r="16034" b="5499"/>
          <a:stretch/>
        </p:blipFill>
        <p:spPr bwMode="auto">
          <a:xfrm>
            <a:off x="11073134" y="17747468"/>
            <a:ext cx="4700561" cy="4798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7"/>
          <p:cNvPicPr>
            <a:picLocks noChangeAspect="1" noChangeArrowheads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51" t="19195" r="15976" b="8365"/>
          <a:stretch/>
        </p:blipFill>
        <p:spPr bwMode="auto">
          <a:xfrm>
            <a:off x="11073136" y="22750420"/>
            <a:ext cx="4700556" cy="48044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7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35" t="14201" r="14591" b="13554"/>
          <a:stretch/>
        </p:blipFill>
        <p:spPr bwMode="auto">
          <a:xfrm>
            <a:off x="16113694" y="2722457"/>
            <a:ext cx="4700564" cy="47914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8"/>
          <p:cNvPicPr>
            <a:picLocks noChangeAspect="1" noChangeArrowheads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66" t="13649" r="14361" b="14781"/>
          <a:stretch/>
        </p:blipFill>
        <p:spPr bwMode="auto">
          <a:xfrm>
            <a:off x="16113696" y="7722429"/>
            <a:ext cx="4700560" cy="4746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9"/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66" t="15346" r="14360" b="12213"/>
          <a:stretch/>
        </p:blipFill>
        <p:spPr bwMode="auto">
          <a:xfrm>
            <a:off x="16113696" y="12683199"/>
            <a:ext cx="4700560" cy="48044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10"/>
          <p:cNvPicPr>
            <a:picLocks noChangeAspect="1" noChangeArrowheads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66" t="20390" r="14360" b="7148"/>
          <a:stretch/>
        </p:blipFill>
        <p:spPr bwMode="auto">
          <a:xfrm>
            <a:off x="16113696" y="17743768"/>
            <a:ext cx="4700561" cy="48058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11"/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02" t="18881" r="14324" b="8768"/>
          <a:stretch/>
        </p:blipFill>
        <p:spPr bwMode="auto">
          <a:xfrm>
            <a:off x="16113696" y="22753406"/>
            <a:ext cx="4700561" cy="4798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" name="直線矢印コネクタ 2"/>
          <p:cNvCxnSpPr/>
          <p:nvPr/>
        </p:nvCxnSpPr>
        <p:spPr>
          <a:xfrm flipH="1">
            <a:off x="3780285" y="4803877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/>
          <p:cNvCxnSpPr/>
          <p:nvPr/>
        </p:nvCxnSpPr>
        <p:spPr>
          <a:xfrm flipH="1">
            <a:off x="3501100" y="10560993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/>
          <p:cNvCxnSpPr/>
          <p:nvPr/>
        </p:nvCxnSpPr>
        <p:spPr>
          <a:xfrm flipH="1">
            <a:off x="2890205" y="15673561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/>
          <p:cNvCxnSpPr/>
          <p:nvPr/>
        </p:nvCxnSpPr>
        <p:spPr>
          <a:xfrm flipH="1">
            <a:off x="10140139" y="10200953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/>
          <p:cNvCxnSpPr/>
          <p:nvPr/>
        </p:nvCxnSpPr>
        <p:spPr>
          <a:xfrm flipH="1">
            <a:off x="8339450" y="4296297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/>
          <p:cNvCxnSpPr/>
          <p:nvPr/>
        </p:nvCxnSpPr>
        <p:spPr>
          <a:xfrm flipH="1">
            <a:off x="9048444" y="4653927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/>
          <p:nvPr/>
        </p:nvCxnSpPr>
        <p:spPr>
          <a:xfrm flipH="1">
            <a:off x="7320252" y="16428366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/>
          <p:cNvCxnSpPr/>
          <p:nvPr/>
        </p:nvCxnSpPr>
        <p:spPr>
          <a:xfrm flipH="1">
            <a:off x="8372059" y="16681673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 flipH="1">
            <a:off x="7032220" y="19634001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/>
          <p:cNvCxnSpPr/>
          <p:nvPr/>
        </p:nvCxnSpPr>
        <p:spPr>
          <a:xfrm flipH="1">
            <a:off x="9132178" y="20774554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/>
          <p:nvPr/>
        </p:nvCxnSpPr>
        <p:spPr>
          <a:xfrm flipH="1">
            <a:off x="9935690" y="18769905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/>
          <p:cNvCxnSpPr/>
          <p:nvPr/>
        </p:nvCxnSpPr>
        <p:spPr>
          <a:xfrm flipH="1">
            <a:off x="9924115" y="20041749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/>
          <p:cNvCxnSpPr/>
          <p:nvPr/>
        </p:nvCxnSpPr>
        <p:spPr>
          <a:xfrm flipH="1">
            <a:off x="7447229" y="25728973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矢印コネクタ 35"/>
          <p:cNvCxnSpPr/>
          <p:nvPr/>
        </p:nvCxnSpPr>
        <p:spPr>
          <a:xfrm flipH="1">
            <a:off x="7359631" y="26311185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矢印コネクタ 36"/>
          <p:cNvCxnSpPr/>
          <p:nvPr/>
        </p:nvCxnSpPr>
        <p:spPr>
          <a:xfrm flipH="1">
            <a:off x="9699074" y="25826689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/>
          <p:cNvCxnSpPr/>
          <p:nvPr/>
        </p:nvCxnSpPr>
        <p:spPr>
          <a:xfrm flipH="1">
            <a:off x="7134590" y="25656965"/>
            <a:ext cx="288032" cy="288032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/>
          <p:cNvSpPr txBox="1"/>
          <p:nvPr/>
        </p:nvSpPr>
        <p:spPr>
          <a:xfrm>
            <a:off x="1579081" y="1547346"/>
            <a:ext cx="319831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Nov. 11, 2015</a:t>
            </a:r>
          </a:p>
          <a:p>
            <a:pPr algn="ct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Resistance to </a:t>
            </a:r>
            <a:r>
              <a:rPr lang="en-US" altLang="ja-JP" sz="2400" dirty="0" err="1">
                <a:latin typeface="Arial" panose="020B0604020202020204" pitchFamily="34" charset="0"/>
                <a:cs typeface="Arial" panose="020B0604020202020204" pitchFamily="34" charset="0"/>
              </a:rPr>
              <a:t>gefitinib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6036934" y="1547346"/>
            <a:ext cx="465063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Jan. 19, 2016</a:t>
            </a:r>
          </a:p>
          <a:p>
            <a:pPr algn="ct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Resistance to CDDP+PEM+BEV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1446754" y="1547346"/>
            <a:ext cx="3953326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May 2, 2016</a:t>
            </a:r>
          </a:p>
          <a:p>
            <a:pPr algn="ct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After whole-brain irradiation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6752613" y="1547346"/>
            <a:ext cx="342273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Jul. 3, 2017</a:t>
            </a:r>
          </a:p>
          <a:p>
            <a:pPr algn="ct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No disease aggravation</a:t>
            </a:r>
            <a:endParaRPr kumimoji="1" lang="en-US" altLang="ja-JP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9425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Custom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Arial</vt:lpstr>
      <vt:lpstr>Calibri</vt:lpstr>
      <vt:lpstr>Office ​​テーマ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/>
  <cp:lastModifiedBy/>
  <cp:revision>12</cp:revision>
  <dcterms:created xsi:type="dcterms:W3CDTF">2019-09-13T00:00:56Z</dcterms:created>
  <dcterms:modified xsi:type="dcterms:W3CDTF">2019-10-16T09:26:08Z</dcterms:modified>
</cp:coreProperties>
</file>